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27E532-63EA-4D5F-8FD1-F07542EA67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73E04B-47A2-4330-A0E9-B9F094740E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A4245A-791E-4384-94BF-3BA79C9799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DB6CD-6125-4557-8262-729CC4D23E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CAACE-A51F-4CF9-B2B2-DB26987EC2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0551E5-67D3-4FC7-962D-74ACE7A303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30A010-0F62-440B-9319-5910BF9D40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248C6C-DDDC-419E-B35F-23A2281A09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EE27D5-356C-4045-9432-9B1689D705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4D7E52-E4A2-4A89-AC24-8941C2864C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219171-4093-4299-A222-1EF11DE132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05C94F-3F68-42A3-97DA-5CD2FC9820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047B3B-7225-4C3C-AABB-BDEC195F2A6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6" Type="http://schemas.openxmlformats.org/officeDocument/2006/relationships/image" Target="../media/image4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76320" y="1752480"/>
            <a:ext cx="9067680" cy="1858320"/>
            <a:chOff x="76320" y="1752480"/>
            <a:chExt cx="9067680" cy="1858320"/>
          </a:xfrm>
        </p:grpSpPr>
        <p:sp>
          <p:nvSpPr>
            <p:cNvPr id="42" name=""/>
            <p:cNvSpPr/>
            <p:nvPr/>
          </p:nvSpPr>
          <p:spPr>
            <a:xfrm>
              <a:off x="76320" y="1752480"/>
              <a:ext cx="9067680" cy="1858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ourier New"/>
                </a:rPr>
                <a:t> 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Courier New"/>
                </a:rPr>
                <a:t>TNFRSF11A_exon9a </a:t>
              </a:r>
              <a:r>
                <a:rPr b="0" lang="en-US" sz="1600" spc="-1" strike="noStrike">
                  <a:solidFill>
                    <a:srgbClr val="000000"/>
                  </a:solidFill>
                  <a:latin typeface="Courier New"/>
                </a:rPr>
                <a:t>             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</a:rPr>
                <a:t>1489nt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:gctgatgggaggctcccaagctcagcgagggcaggtgccgggtctggaagctcccctggtggccagtcccctgcatctgatta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ourier New"/>
                </a:rPr>
                <a:t>497aa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 : A  D  G  R  L  P  S  S  A  R  A  G  A  G  S  G  S  S  P  G  G  Q  S  P  A  S  D  -  52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cccacacccgcccaggaagctgactgaagcccatagcacactgattattcacaactcttgggtcactctggaatacccagacc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 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Courier New"/>
                </a:rPr>
                <a:t>ttctgctgccacctgctgaatggccatgttttctaaagtccatgggtgctcccagttctgaaatgtgactggaaacagtaa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7155000" y="2124000"/>
              <a:ext cx="1954080" cy="247680"/>
              <a:chOff x="7155000" y="2124000"/>
              <a:chExt cx="1954080" cy="247680"/>
            </a:xfrm>
          </p:grpSpPr>
          <p:grpSp>
            <p:nvGrpSpPr>
              <p:cNvPr id="44" name=""/>
              <p:cNvGrpSpPr/>
              <p:nvPr/>
            </p:nvGrpSpPr>
            <p:grpSpPr>
              <a:xfrm>
                <a:off x="7719840" y="2143080"/>
                <a:ext cx="761760" cy="228600"/>
                <a:chOff x="7719840" y="2143080"/>
                <a:chExt cx="761760" cy="228600"/>
              </a:xfrm>
            </p:grpSpPr>
            <p:sp>
              <p:nvSpPr>
                <p:cNvPr id="45" name=""/>
                <p:cNvSpPr/>
                <p:nvPr/>
              </p:nvSpPr>
              <p:spPr>
                <a:xfrm>
                  <a:off x="8177040" y="2257560"/>
                  <a:ext cx="3045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"/>
                <p:cNvSpPr/>
                <p:nvPr/>
              </p:nvSpPr>
              <p:spPr>
                <a:xfrm>
                  <a:off x="8100720" y="2143080"/>
                  <a:ext cx="0" cy="228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"/>
                <p:cNvSpPr/>
                <p:nvPr/>
              </p:nvSpPr>
              <p:spPr>
                <a:xfrm flipH="1">
                  <a:off x="7719840" y="2257560"/>
                  <a:ext cx="3045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8" name=""/>
              <p:cNvSpPr/>
              <p:nvPr/>
            </p:nvSpPr>
            <p:spPr>
              <a:xfrm>
                <a:off x="8443800" y="212544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Exon 9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7155000" y="2124000"/>
                <a:ext cx="595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Exon 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0" name=""/>
            <p:cNvGrpSpPr/>
            <p:nvPr/>
          </p:nvGrpSpPr>
          <p:grpSpPr>
            <a:xfrm>
              <a:off x="4973400" y="3205080"/>
              <a:ext cx="2011680" cy="263520"/>
              <a:chOff x="4973400" y="3205080"/>
              <a:chExt cx="2011680" cy="263520"/>
            </a:xfrm>
          </p:grpSpPr>
          <p:grpSp>
            <p:nvGrpSpPr>
              <p:cNvPr id="51" name=""/>
              <p:cNvGrpSpPr/>
              <p:nvPr/>
            </p:nvGrpSpPr>
            <p:grpSpPr>
              <a:xfrm>
                <a:off x="5595840" y="3222360"/>
                <a:ext cx="761760" cy="228600"/>
                <a:chOff x="5595840" y="3222360"/>
                <a:chExt cx="761760" cy="228600"/>
              </a:xfrm>
            </p:grpSpPr>
            <p:sp>
              <p:nvSpPr>
                <p:cNvPr id="52" name=""/>
                <p:cNvSpPr/>
                <p:nvPr/>
              </p:nvSpPr>
              <p:spPr>
                <a:xfrm>
                  <a:off x="6053040" y="3336840"/>
                  <a:ext cx="3045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"/>
                <p:cNvSpPr/>
                <p:nvPr/>
              </p:nvSpPr>
              <p:spPr>
                <a:xfrm>
                  <a:off x="5976720" y="3222360"/>
                  <a:ext cx="0" cy="228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"/>
                <p:cNvSpPr/>
                <p:nvPr/>
              </p:nvSpPr>
              <p:spPr>
                <a:xfrm flipH="1">
                  <a:off x="5595840" y="3336840"/>
                  <a:ext cx="3045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5" name=""/>
              <p:cNvSpPr/>
              <p:nvPr/>
            </p:nvSpPr>
            <p:spPr>
              <a:xfrm>
                <a:off x="6319800" y="320508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Exon 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4973400" y="322236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Exon 9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57" name=""/>
          <p:cNvGrpSpPr/>
          <p:nvPr/>
        </p:nvGrpSpPr>
        <p:grpSpPr>
          <a:xfrm>
            <a:off x="358920" y="315720"/>
            <a:ext cx="8426160" cy="1281600"/>
            <a:chOff x="358920" y="315720"/>
            <a:chExt cx="8426160" cy="1281600"/>
          </a:xfrm>
        </p:grpSpPr>
        <p:sp>
          <p:nvSpPr>
            <p:cNvPr id="58" name=""/>
            <p:cNvSpPr/>
            <p:nvPr/>
          </p:nvSpPr>
          <p:spPr>
            <a:xfrm>
              <a:off x="358920" y="315720"/>
              <a:ext cx="8426160" cy="1189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just">
                <a:lnSpc>
                  <a:spcPct val="150000"/>
                </a:lnSpc>
                <a:tabLst>
                  <a:tab algn="l" pos="0"/>
                  <a:tab algn="l" pos="57312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ctcaatctatctccactcaacccac</a:t>
              </a: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g</a:t>
              </a:r>
              <a:r>
                <a:rPr b="0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AT</a:t>
              </a:r>
              <a:r>
                <a:rPr b="0" lang="en-US" sz="1600" spc="-1" strike="noStrike" u="sng">
                  <a:solidFill>
                    <a:srgbClr val="000000"/>
                  </a:solidFill>
                  <a:uFillTx/>
                  <a:latin typeface="Courier New"/>
                  <a:ea typeface="Times New Roman"/>
                </a:rPr>
                <a:t>TAA</a:t>
              </a:r>
              <a:r>
                <a:rPr b="0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CCCACACCCGCCCAGGAAGCTGACTGAAGCCCATAGCACACTGATTATTCACAACTCTTGGGTCACTCTGGAATACCCAGACCCTTCTGCTGCCACCTGCTGAATGGCCATGTTTTCTAAAGTCCATGGG</a:t>
              </a:r>
              <a:r>
                <a:rPr b="0" lang="fr-FR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TGC</a:t>
              </a:r>
              <a:r>
                <a:rPr b="0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TCCCAGTTCT</a:t>
              </a:r>
              <a:r>
                <a:rPr b="1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gt</a:t>
              </a:r>
              <a:r>
                <a:rPr b="0" lang="en-US" sz="1600" spc="-1" strike="noStrike">
                  <a:solidFill>
                    <a:srgbClr val="000000"/>
                  </a:solidFill>
                  <a:latin typeface="Courier New"/>
                  <a:ea typeface="Times New Roman"/>
                </a:rPr>
                <a:t>gagtgtgagctgatcttgtcatt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9" name=""/>
            <p:cNvGrpSpPr/>
            <p:nvPr/>
          </p:nvGrpSpPr>
          <p:grpSpPr>
            <a:xfrm>
              <a:off x="3376440" y="339840"/>
              <a:ext cx="761760" cy="228600"/>
              <a:chOff x="3376440" y="339840"/>
              <a:chExt cx="761760" cy="228600"/>
            </a:xfrm>
          </p:grpSpPr>
          <p:sp>
            <p:nvSpPr>
              <p:cNvPr id="60" name=""/>
              <p:cNvSpPr/>
              <p:nvPr/>
            </p:nvSpPr>
            <p:spPr>
              <a:xfrm>
                <a:off x="3833640" y="45432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3757320" y="339840"/>
                <a:ext cx="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 flipH="1">
                <a:off x="3376440" y="45432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3" name=""/>
            <p:cNvSpPr/>
            <p:nvPr/>
          </p:nvSpPr>
          <p:spPr>
            <a:xfrm>
              <a:off x="4186080" y="322200"/>
              <a:ext cx="66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xon 9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754360" y="320760"/>
              <a:ext cx="64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ntron 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5" name=""/>
            <p:cNvGrpSpPr/>
            <p:nvPr/>
          </p:nvGrpSpPr>
          <p:grpSpPr>
            <a:xfrm>
              <a:off x="5076720" y="1368360"/>
              <a:ext cx="761760" cy="228600"/>
              <a:chOff x="5076720" y="1368360"/>
              <a:chExt cx="761760" cy="228600"/>
            </a:xfrm>
          </p:grpSpPr>
          <p:sp>
            <p:nvSpPr>
              <p:cNvPr id="66" name=""/>
              <p:cNvSpPr/>
              <p:nvPr/>
            </p:nvSpPr>
            <p:spPr>
              <a:xfrm>
                <a:off x="5533920" y="148284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5457600" y="1368360"/>
                <a:ext cx="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flipH="1">
                <a:off x="5076720" y="148284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9" name=""/>
            <p:cNvSpPr/>
            <p:nvPr/>
          </p:nvSpPr>
          <p:spPr>
            <a:xfrm>
              <a:off x="5886360" y="1351080"/>
              <a:ext cx="71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ntron 9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454280" y="1349280"/>
              <a:ext cx="66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xon 9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1" name=""/>
          <p:cNvSpPr/>
          <p:nvPr/>
        </p:nvSpPr>
        <p:spPr>
          <a:xfrm>
            <a:off x="138240" y="763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46160" y="15238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3" name=""/>
          <p:cNvGrpSpPr/>
          <p:nvPr/>
        </p:nvGrpSpPr>
        <p:grpSpPr>
          <a:xfrm>
            <a:off x="723960" y="5238720"/>
            <a:ext cx="762120" cy="75960"/>
            <a:chOff x="723960" y="5238720"/>
            <a:chExt cx="762120" cy="75960"/>
          </a:xfrm>
        </p:grpSpPr>
        <p:sp>
          <p:nvSpPr>
            <p:cNvPr id="74" name=""/>
            <p:cNvSpPr/>
            <p:nvPr/>
          </p:nvSpPr>
          <p:spPr>
            <a:xfrm>
              <a:off x="723960" y="5238720"/>
              <a:ext cx="762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723960" y="5314680"/>
              <a:ext cx="609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6" name=""/>
          <p:cNvSpPr/>
          <p:nvPr/>
        </p:nvSpPr>
        <p:spPr>
          <a:xfrm>
            <a:off x="762120" y="3886200"/>
            <a:ext cx="533160" cy="380880"/>
          </a:xfrm>
          <a:prstGeom prst="pentagon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NF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rot="5400000">
            <a:off x="971280" y="5403600"/>
            <a:ext cx="165240" cy="15264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rot="5400000">
            <a:off x="711000" y="5833800"/>
            <a:ext cx="685800" cy="15264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rot="5400000">
            <a:off x="939600" y="6295680"/>
            <a:ext cx="228600" cy="15264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774720" y="4165560"/>
            <a:ext cx="533520" cy="380880"/>
          </a:xfrm>
          <a:prstGeom prst="pentagon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NF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774720" y="4457880"/>
            <a:ext cx="533520" cy="380880"/>
          </a:xfrm>
          <a:prstGeom prst="pentagon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NF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774720" y="4762440"/>
            <a:ext cx="533520" cy="381240"/>
          </a:xfrm>
          <a:prstGeom prst="pentagon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NF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863640" y="5130720"/>
            <a:ext cx="368280" cy="2667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686880" y="6519960"/>
            <a:ext cx="75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tRAN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60440" y="3936960"/>
            <a:ext cx="22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59000" y="42321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59000" y="4518000"/>
            <a:ext cx="30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458640" y="4830840"/>
            <a:ext cx="32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9" name=""/>
          <p:cNvGrpSpPr/>
          <p:nvPr/>
        </p:nvGrpSpPr>
        <p:grpSpPr>
          <a:xfrm>
            <a:off x="2629080" y="5238720"/>
            <a:ext cx="761760" cy="75960"/>
            <a:chOff x="2629080" y="5238720"/>
            <a:chExt cx="761760" cy="75960"/>
          </a:xfrm>
        </p:grpSpPr>
        <p:sp>
          <p:nvSpPr>
            <p:cNvPr id="90" name=""/>
            <p:cNvSpPr/>
            <p:nvPr/>
          </p:nvSpPr>
          <p:spPr>
            <a:xfrm>
              <a:off x="2629080" y="5238720"/>
              <a:ext cx="761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629080" y="5314680"/>
              <a:ext cx="609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" name=""/>
          <p:cNvSpPr/>
          <p:nvPr/>
        </p:nvSpPr>
        <p:spPr>
          <a:xfrm>
            <a:off x="2666880" y="3886200"/>
            <a:ext cx="533520" cy="380880"/>
          </a:xfrm>
          <a:prstGeom prst="pentagon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NF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rot="5400000">
            <a:off x="2876040" y="5403960"/>
            <a:ext cx="165240" cy="15228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rot="5400000">
            <a:off x="2615760" y="5834160"/>
            <a:ext cx="685800" cy="15228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679840" y="4165560"/>
            <a:ext cx="533160" cy="380880"/>
          </a:xfrm>
          <a:prstGeom prst="pentagon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NF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2679840" y="4457880"/>
            <a:ext cx="533160" cy="380880"/>
          </a:xfrm>
          <a:prstGeom prst="pentagon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NF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679840" y="4762440"/>
            <a:ext cx="533160" cy="381240"/>
          </a:xfrm>
          <a:prstGeom prst="pentagon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NFR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2768760" y="5130720"/>
            <a:ext cx="368280" cy="2667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2365560" y="3936960"/>
            <a:ext cx="22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364120" y="42321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364120" y="4518000"/>
            <a:ext cx="30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363760" y="4830840"/>
            <a:ext cx="32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701360" y="5119560"/>
            <a:ext cx="64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on 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523880" y="5105520"/>
            <a:ext cx="152640" cy="304560"/>
          </a:xfrm>
          <a:custGeom>
            <a:avLst/>
            <a:gdLst>
              <a:gd name="textAreaLeft" fmla="*/ 0 w 152640"/>
              <a:gd name="textAreaRight" fmla="*/ 55080 w 152640"/>
              <a:gd name="textAreaTop" fmla="*/ 7920 h 304560"/>
              <a:gd name="textAreaBottom" fmla="*/ 296640 h 304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2362320" y="5105520"/>
            <a:ext cx="155520" cy="304560"/>
          </a:xfrm>
          <a:custGeom>
            <a:avLst/>
            <a:gdLst>
              <a:gd name="textAreaLeft" fmla="*/ 99360 w 155520"/>
              <a:gd name="textAreaRight" fmla="*/ 155520 w 155520"/>
              <a:gd name="textAreaTop" fmla="*/ 7920 h 304560"/>
              <a:gd name="textAreaBottom" fmla="*/ 296640 h 3045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1696680" y="5334120"/>
            <a:ext cx="64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on 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523880" y="5410080"/>
            <a:ext cx="152640" cy="152640"/>
          </a:xfrm>
          <a:custGeom>
            <a:avLst/>
            <a:gdLst>
              <a:gd name="textAreaLeft" fmla="*/ 0 w 152640"/>
              <a:gd name="textAreaRight" fmla="*/ 55080 w 152640"/>
              <a:gd name="textAreaTop" fmla="*/ 3960 h 152640"/>
              <a:gd name="textAreaBottom" fmla="*/ 148680 h 152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373480" y="5410080"/>
            <a:ext cx="155520" cy="152640"/>
          </a:xfrm>
          <a:custGeom>
            <a:avLst/>
            <a:gdLst>
              <a:gd name="textAreaLeft" fmla="*/ 99360 w 155520"/>
              <a:gd name="textAreaRight" fmla="*/ 155520 w 155520"/>
              <a:gd name="textAreaTop" fmla="*/ 3960 h 152640"/>
              <a:gd name="textAreaBottom" fmla="*/ 148680 h 152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1523880" y="5562720"/>
            <a:ext cx="152640" cy="685800"/>
          </a:xfrm>
          <a:custGeom>
            <a:avLst/>
            <a:gdLst>
              <a:gd name="textAreaLeft" fmla="*/ 0 w 152640"/>
              <a:gd name="textAreaRight" fmla="*/ 55080 w 152640"/>
              <a:gd name="textAreaTop" fmla="*/ 17640 h 685800"/>
              <a:gd name="textAreaBottom" fmla="*/ 668160 h 6858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371680" y="5565600"/>
            <a:ext cx="155520" cy="685800"/>
          </a:xfrm>
          <a:custGeom>
            <a:avLst/>
            <a:gdLst>
              <a:gd name="textAreaLeft" fmla="*/ 99360 w 155520"/>
              <a:gd name="textAreaRight" fmla="*/ 155520 w 155520"/>
              <a:gd name="textAreaTop" fmla="*/ 17640 h 685800"/>
              <a:gd name="textAreaBottom" fmla="*/ 668160 h 685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695240" y="5773680"/>
            <a:ext cx="64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on 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1523880" y="6253200"/>
            <a:ext cx="152640" cy="223920"/>
          </a:xfrm>
          <a:custGeom>
            <a:avLst/>
            <a:gdLst>
              <a:gd name="textAreaLeft" fmla="*/ 0 w 152640"/>
              <a:gd name="textAreaRight" fmla="*/ 55080 w 152640"/>
              <a:gd name="textAreaTop" fmla="*/ 5760 h 223920"/>
              <a:gd name="textAreaBottom" fmla="*/ 218160 h 223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692720" y="6221520"/>
            <a:ext cx="72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on 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2309400" y="6507000"/>
            <a:ext cx="140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utative RANK-9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3429000" y="3886200"/>
            <a:ext cx="152280" cy="990720"/>
          </a:xfrm>
          <a:custGeom>
            <a:avLst/>
            <a:gdLst>
              <a:gd name="textAreaLeft" fmla="*/ 0 w 152280"/>
              <a:gd name="textAreaRight" fmla="*/ 55080 w 152280"/>
              <a:gd name="textAreaTop" fmla="*/ 25560 h 990720"/>
              <a:gd name="textAreaBottom" fmla="*/ 965160 h 9907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533040" y="4233960"/>
            <a:ext cx="819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on 1-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40040" y="37339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8" name=""/>
          <p:cNvGrpSpPr/>
          <p:nvPr/>
        </p:nvGrpSpPr>
        <p:grpSpPr>
          <a:xfrm>
            <a:off x="4038480" y="5219640"/>
            <a:ext cx="4926240" cy="1259280"/>
            <a:chOff x="4038480" y="5219640"/>
            <a:chExt cx="4926240" cy="1259280"/>
          </a:xfrm>
        </p:grpSpPr>
        <p:sp>
          <p:nvSpPr>
            <p:cNvPr id="119" name=""/>
            <p:cNvSpPr/>
            <p:nvPr/>
          </p:nvSpPr>
          <p:spPr>
            <a:xfrm>
              <a:off x="7199280" y="5473800"/>
              <a:ext cx="801720" cy="243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Ex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8659800" y="5472000"/>
              <a:ext cx="304920" cy="2462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Ex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8151840" y="5470560"/>
              <a:ext cx="358920" cy="246240"/>
            </a:xfrm>
            <a:prstGeom prst="rect">
              <a:avLst/>
            </a:prstGeom>
            <a:blipFill rotWithShape="0">
              <a:blip r:embed="rId6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Ex9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2" name=""/>
            <p:cNvGrpSpPr/>
            <p:nvPr/>
          </p:nvGrpSpPr>
          <p:grpSpPr>
            <a:xfrm>
              <a:off x="8001000" y="5713560"/>
              <a:ext cx="152280" cy="304560"/>
              <a:chOff x="8001000" y="5713560"/>
              <a:chExt cx="152280" cy="304560"/>
            </a:xfrm>
          </p:grpSpPr>
          <p:sp>
            <p:nvSpPr>
              <p:cNvPr id="123" name=""/>
              <p:cNvSpPr/>
              <p:nvPr/>
            </p:nvSpPr>
            <p:spPr>
              <a:xfrm>
                <a:off x="8001000" y="5713560"/>
                <a:ext cx="75960" cy="304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 flipH="1">
                <a:off x="8076960" y="5713560"/>
                <a:ext cx="76320" cy="304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5" name=""/>
            <p:cNvGrpSpPr/>
            <p:nvPr/>
          </p:nvGrpSpPr>
          <p:grpSpPr>
            <a:xfrm>
              <a:off x="8508960" y="5719680"/>
              <a:ext cx="152280" cy="304920"/>
              <a:chOff x="8508960" y="5719680"/>
              <a:chExt cx="152280" cy="304920"/>
            </a:xfrm>
          </p:grpSpPr>
          <p:sp>
            <p:nvSpPr>
              <p:cNvPr id="126" name=""/>
              <p:cNvSpPr/>
              <p:nvPr/>
            </p:nvSpPr>
            <p:spPr>
              <a:xfrm>
                <a:off x="8508960" y="5719680"/>
                <a:ext cx="75960" cy="30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 flipH="1">
                <a:off x="8584920" y="5719680"/>
                <a:ext cx="76320" cy="30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8" name=""/>
            <p:cNvGrpSpPr/>
            <p:nvPr/>
          </p:nvGrpSpPr>
          <p:grpSpPr>
            <a:xfrm>
              <a:off x="8120160" y="5313600"/>
              <a:ext cx="75960" cy="152280"/>
              <a:chOff x="8120160" y="5313600"/>
              <a:chExt cx="75960" cy="152280"/>
            </a:xfrm>
          </p:grpSpPr>
          <p:sp>
            <p:nvSpPr>
              <p:cNvPr id="129" name=""/>
              <p:cNvSpPr/>
              <p:nvPr/>
            </p:nvSpPr>
            <p:spPr>
              <a:xfrm>
                <a:off x="8120160" y="5313600"/>
                <a:ext cx="75960" cy="763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200" bIns="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8158320" y="538992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1" name=""/>
            <p:cNvSpPr/>
            <p:nvPr/>
          </p:nvSpPr>
          <p:spPr>
            <a:xfrm flipH="1">
              <a:off x="8696160" y="5413320"/>
              <a:ext cx="136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2" name=""/>
            <p:cNvGrpSpPr/>
            <p:nvPr/>
          </p:nvGrpSpPr>
          <p:grpSpPr>
            <a:xfrm>
              <a:off x="4038480" y="5219640"/>
              <a:ext cx="3160440" cy="741240"/>
              <a:chOff x="4038480" y="5219640"/>
              <a:chExt cx="3160440" cy="741240"/>
            </a:xfrm>
          </p:grpSpPr>
          <p:sp>
            <p:nvSpPr>
              <p:cNvPr id="133" name=""/>
              <p:cNvSpPr/>
              <p:nvPr/>
            </p:nvSpPr>
            <p:spPr>
              <a:xfrm>
                <a:off x="4444920" y="5473440"/>
                <a:ext cx="241560" cy="243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Ex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4808520" y="5473440"/>
                <a:ext cx="284040" cy="243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Ex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5173560" y="5473440"/>
                <a:ext cx="365400" cy="243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Ex 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5740560" y="5473440"/>
                <a:ext cx="284040" cy="243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Ex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6105600" y="5473440"/>
                <a:ext cx="323640" cy="243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Ex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6510240" y="5473440"/>
                <a:ext cx="325440" cy="243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Ex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6910560" y="5473440"/>
                <a:ext cx="206280" cy="243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Ex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4038480" y="5473440"/>
                <a:ext cx="284400" cy="243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Ex1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5619600" y="5473440"/>
                <a:ext cx="120960" cy="2430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2" name=""/>
              <p:cNvGrpSpPr/>
              <p:nvPr/>
            </p:nvGrpSpPr>
            <p:grpSpPr>
              <a:xfrm>
                <a:off x="4322880" y="5716440"/>
                <a:ext cx="122040" cy="244440"/>
                <a:chOff x="4322880" y="5716440"/>
                <a:chExt cx="122040" cy="244440"/>
              </a:xfrm>
            </p:grpSpPr>
            <p:sp>
              <p:nvSpPr>
                <p:cNvPr id="143" name=""/>
                <p:cNvSpPr/>
                <p:nvPr/>
              </p:nvSpPr>
              <p:spPr>
                <a:xfrm>
                  <a:off x="4322880" y="5716440"/>
                  <a:ext cx="6084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"/>
                <p:cNvSpPr/>
                <p:nvPr/>
              </p:nvSpPr>
              <p:spPr>
                <a:xfrm flipH="1">
                  <a:off x="4383720" y="5716440"/>
                  <a:ext cx="6120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5" name=""/>
              <p:cNvGrpSpPr/>
              <p:nvPr/>
            </p:nvGrpSpPr>
            <p:grpSpPr>
              <a:xfrm>
                <a:off x="4686480" y="5716440"/>
                <a:ext cx="122040" cy="244440"/>
                <a:chOff x="4686480" y="5716440"/>
                <a:chExt cx="122040" cy="244440"/>
              </a:xfrm>
            </p:grpSpPr>
            <p:sp>
              <p:nvSpPr>
                <p:cNvPr id="146" name=""/>
                <p:cNvSpPr/>
                <p:nvPr/>
              </p:nvSpPr>
              <p:spPr>
                <a:xfrm>
                  <a:off x="4686480" y="5716440"/>
                  <a:ext cx="6084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"/>
                <p:cNvSpPr/>
                <p:nvPr/>
              </p:nvSpPr>
              <p:spPr>
                <a:xfrm flipH="1">
                  <a:off x="4747320" y="5716440"/>
                  <a:ext cx="6120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8" name=""/>
              <p:cNvGrpSpPr/>
              <p:nvPr/>
            </p:nvGrpSpPr>
            <p:grpSpPr>
              <a:xfrm>
                <a:off x="5092560" y="5716440"/>
                <a:ext cx="80640" cy="244440"/>
                <a:chOff x="5092560" y="5716440"/>
                <a:chExt cx="80640" cy="244440"/>
              </a:xfrm>
            </p:grpSpPr>
            <p:sp>
              <p:nvSpPr>
                <p:cNvPr id="149" name=""/>
                <p:cNvSpPr/>
                <p:nvPr/>
              </p:nvSpPr>
              <p:spPr>
                <a:xfrm>
                  <a:off x="5092560" y="5716440"/>
                  <a:ext cx="4032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"/>
                <p:cNvSpPr/>
                <p:nvPr/>
              </p:nvSpPr>
              <p:spPr>
                <a:xfrm flipH="1">
                  <a:off x="5132520" y="5716440"/>
                  <a:ext cx="4068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51" name=""/>
              <p:cNvGrpSpPr/>
              <p:nvPr/>
            </p:nvGrpSpPr>
            <p:grpSpPr>
              <a:xfrm>
                <a:off x="5538960" y="5716440"/>
                <a:ext cx="80280" cy="244440"/>
                <a:chOff x="5538960" y="5716440"/>
                <a:chExt cx="80280" cy="244440"/>
              </a:xfrm>
            </p:grpSpPr>
            <p:sp>
              <p:nvSpPr>
                <p:cNvPr id="152" name=""/>
                <p:cNvSpPr/>
                <p:nvPr/>
              </p:nvSpPr>
              <p:spPr>
                <a:xfrm>
                  <a:off x="5538960" y="5716440"/>
                  <a:ext cx="3996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 flipH="1">
                  <a:off x="5578920" y="5716440"/>
                  <a:ext cx="4032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prstDash val="sysDot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54" name=""/>
              <p:cNvGrpSpPr/>
              <p:nvPr/>
            </p:nvGrpSpPr>
            <p:grpSpPr>
              <a:xfrm>
                <a:off x="6024600" y="5716440"/>
                <a:ext cx="80640" cy="244440"/>
                <a:chOff x="6024600" y="5716440"/>
                <a:chExt cx="80640" cy="244440"/>
              </a:xfrm>
            </p:grpSpPr>
            <p:sp>
              <p:nvSpPr>
                <p:cNvPr id="155" name=""/>
                <p:cNvSpPr/>
                <p:nvPr/>
              </p:nvSpPr>
              <p:spPr>
                <a:xfrm>
                  <a:off x="6024600" y="5716440"/>
                  <a:ext cx="4032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"/>
                <p:cNvSpPr/>
                <p:nvPr/>
              </p:nvSpPr>
              <p:spPr>
                <a:xfrm flipH="1">
                  <a:off x="6064560" y="5716440"/>
                  <a:ext cx="4068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57" name=""/>
              <p:cNvGrpSpPr/>
              <p:nvPr/>
            </p:nvGrpSpPr>
            <p:grpSpPr>
              <a:xfrm>
                <a:off x="6429240" y="5716440"/>
                <a:ext cx="80640" cy="244440"/>
                <a:chOff x="6429240" y="5716440"/>
                <a:chExt cx="80640" cy="244440"/>
              </a:xfrm>
            </p:grpSpPr>
            <p:sp>
              <p:nvSpPr>
                <p:cNvPr id="158" name=""/>
                <p:cNvSpPr/>
                <p:nvPr/>
              </p:nvSpPr>
              <p:spPr>
                <a:xfrm>
                  <a:off x="6429240" y="5716440"/>
                  <a:ext cx="4032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"/>
                <p:cNvSpPr/>
                <p:nvPr/>
              </p:nvSpPr>
              <p:spPr>
                <a:xfrm flipH="1">
                  <a:off x="6469200" y="5716440"/>
                  <a:ext cx="4068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60" name=""/>
              <p:cNvGrpSpPr/>
              <p:nvPr/>
            </p:nvGrpSpPr>
            <p:grpSpPr>
              <a:xfrm>
                <a:off x="6835680" y="5716440"/>
                <a:ext cx="73080" cy="244440"/>
                <a:chOff x="6835680" y="5716440"/>
                <a:chExt cx="73080" cy="244440"/>
              </a:xfrm>
            </p:grpSpPr>
            <p:sp>
              <p:nvSpPr>
                <p:cNvPr id="161" name=""/>
                <p:cNvSpPr/>
                <p:nvPr/>
              </p:nvSpPr>
              <p:spPr>
                <a:xfrm>
                  <a:off x="6835680" y="5716440"/>
                  <a:ext cx="3636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"/>
                <p:cNvSpPr/>
                <p:nvPr/>
              </p:nvSpPr>
              <p:spPr>
                <a:xfrm flipH="1">
                  <a:off x="6872040" y="5716440"/>
                  <a:ext cx="3672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63" name=""/>
              <p:cNvGrpSpPr/>
              <p:nvPr/>
            </p:nvGrpSpPr>
            <p:grpSpPr>
              <a:xfrm>
                <a:off x="7120080" y="5716440"/>
                <a:ext cx="78840" cy="244440"/>
                <a:chOff x="7120080" y="5716440"/>
                <a:chExt cx="78840" cy="244440"/>
              </a:xfrm>
            </p:grpSpPr>
            <p:sp>
              <p:nvSpPr>
                <p:cNvPr id="164" name=""/>
                <p:cNvSpPr/>
                <p:nvPr/>
              </p:nvSpPr>
              <p:spPr>
                <a:xfrm>
                  <a:off x="7120080" y="5716440"/>
                  <a:ext cx="3924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"/>
                <p:cNvSpPr/>
                <p:nvPr/>
              </p:nvSpPr>
              <p:spPr>
                <a:xfrm flipH="1">
                  <a:off x="7159320" y="5716440"/>
                  <a:ext cx="39600" cy="244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66" name=""/>
              <p:cNvSpPr/>
              <p:nvPr/>
            </p:nvSpPr>
            <p:spPr>
              <a:xfrm>
                <a:off x="5810400" y="5414760"/>
                <a:ext cx="136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5716800" y="5219640"/>
                <a:ext cx="30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8" name=""/>
            <p:cNvSpPr/>
            <p:nvPr/>
          </p:nvSpPr>
          <p:spPr>
            <a:xfrm>
              <a:off x="8626680" y="5224680"/>
              <a:ext cx="30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5613120" y="6202440"/>
              <a:ext cx="2221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utative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TNFRSF11A_exon9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0" name=""/>
          <p:cNvSpPr/>
          <p:nvPr/>
        </p:nvSpPr>
        <p:spPr>
          <a:xfrm>
            <a:off x="3964320" y="487692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1T16:17:34Z</dcterms:created>
  <dc:creator>tasos p</dc:creator>
  <dc:description/>
  <dc:language>en-US</dc:language>
  <cp:lastModifiedBy>tasos p</cp:lastModifiedBy>
  <dcterms:modified xsi:type="dcterms:W3CDTF">2012-01-31T18:40:17Z</dcterms:modified>
  <cp:revision>15</cp:revision>
  <dc:subject/>
  <dc:title>Διαφάνεια 1</dc:title>
</cp:coreProperties>
</file>